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000000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맑은 고딕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000000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DA84262-3269-42A3-8BAE-516FF734338D}" type="slidenum">
              <a:rPr b="0" lang="ko-KR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23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2" name="슬라이드 번호 개체 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F6FA934-CB56-47C9-8EF1-D1808BAFD280}" type="slidenum">
              <a:rPr b="0" lang="ko-KR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7CBBBC-D193-410F-A513-F0BCF107ACC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0B7CFE-CFE7-484C-A544-B4BD25A015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A7B896-B595-44EB-950C-71FC4C9A2B5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A509C3-5B99-47CD-B389-7989BCC2155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D211A0-98E8-44EC-8C69-A8360B35A0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0A4BD3-3189-4025-97EF-5101AEFBBB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893980-5E31-438A-84B5-A14C74EF5F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3846BD-88B5-40C9-AB69-351AA193EB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2F41D2-3E8F-41CC-9989-3913D541D7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031476-D353-43BC-B719-470A5CA85B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9960EC-0358-48A5-81EB-58AD172292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78C2FE-AFBF-4AD2-8D82-0C5A47619F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5D34E6F-93B7-4C3F-8A6E-BD1E0BDB49BB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9.png"/><Relationship Id="rId3" Type="http://schemas.openxmlformats.org/officeDocument/2006/relationships/image" Target="../media/image10.pn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그룹 71"/>
          <p:cNvGrpSpPr/>
          <p:nvPr/>
        </p:nvGrpSpPr>
        <p:grpSpPr>
          <a:xfrm>
            <a:off x="1341360" y="4578480"/>
            <a:ext cx="1224000" cy="1793880"/>
            <a:chOff x="1341360" y="4578480"/>
            <a:chExt cx="1224000" cy="1793880"/>
          </a:xfrm>
        </p:grpSpPr>
        <p:sp>
          <p:nvSpPr>
            <p:cNvPr id="49" name="직사각형 72"/>
            <p:cNvSpPr/>
            <p:nvPr/>
          </p:nvSpPr>
          <p:spPr>
            <a:xfrm>
              <a:off x="1341360" y="4610160"/>
              <a:ext cx="936720" cy="173052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0" name="직사각형 73"/>
            <p:cNvSpPr/>
            <p:nvPr/>
          </p:nvSpPr>
          <p:spPr>
            <a:xfrm>
              <a:off x="1628640" y="4578480"/>
              <a:ext cx="936720" cy="1793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grpSp>
        <p:nvGrpSpPr>
          <p:cNvPr id="51" name="그룹 54"/>
          <p:cNvGrpSpPr/>
          <p:nvPr/>
        </p:nvGrpSpPr>
        <p:grpSpPr>
          <a:xfrm>
            <a:off x="1341360" y="6473880"/>
            <a:ext cx="1224000" cy="1266840"/>
            <a:chOff x="1341360" y="6473880"/>
            <a:chExt cx="1224000" cy="1266840"/>
          </a:xfrm>
        </p:grpSpPr>
        <p:sp>
          <p:nvSpPr>
            <p:cNvPr id="52" name="직사각형 55"/>
            <p:cNvSpPr/>
            <p:nvPr/>
          </p:nvSpPr>
          <p:spPr>
            <a:xfrm>
              <a:off x="1341360" y="6495840"/>
              <a:ext cx="936720" cy="117972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3" name="직사각형 56"/>
            <p:cNvSpPr/>
            <p:nvPr/>
          </p:nvSpPr>
          <p:spPr>
            <a:xfrm>
              <a:off x="1628640" y="6473880"/>
              <a:ext cx="936720" cy="1266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grpSp>
        <p:nvGrpSpPr>
          <p:cNvPr id="54" name="그룹 49"/>
          <p:cNvGrpSpPr/>
          <p:nvPr/>
        </p:nvGrpSpPr>
        <p:grpSpPr>
          <a:xfrm>
            <a:off x="1341360" y="1403280"/>
            <a:ext cx="1224000" cy="3005280"/>
            <a:chOff x="1341360" y="1403280"/>
            <a:chExt cx="1224000" cy="3005280"/>
          </a:xfrm>
        </p:grpSpPr>
        <p:sp>
          <p:nvSpPr>
            <p:cNvPr id="55" name="직사각형 46"/>
            <p:cNvSpPr/>
            <p:nvPr/>
          </p:nvSpPr>
          <p:spPr>
            <a:xfrm>
              <a:off x="1341360" y="1456920"/>
              <a:ext cx="936720" cy="28976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6" name="직사각형 47"/>
            <p:cNvSpPr/>
            <p:nvPr/>
          </p:nvSpPr>
          <p:spPr>
            <a:xfrm>
              <a:off x="1628640" y="1403280"/>
              <a:ext cx="936720" cy="3005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sp>
        <p:nvSpPr>
          <p:cNvPr id="57" name="직사각형 3"/>
          <p:cNvSpPr/>
          <p:nvPr/>
        </p:nvSpPr>
        <p:spPr>
          <a:xfrm>
            <a:off x="2278080" y="1461960"/>
            <a:ext cx="2519280" cy="2890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HCT116 (mock, 5-aza-dC, 2Gy, 5Gy)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8" name="직사각형 8"/>
          <p:cNvSpPr/>
          <p:nvPr/>
        </p:nvSpPr>
        <p:spPr>
          <a:xfrm>
            <a:off x="2278080" y="6497640"/>
            <a:ext cx="2519280" cy="2872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Correlation RT-PCR and Methylation (7 genes)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9" name="TextBox 12"/>
          <p:cNvSpPr/>
          <p:nvPr/>
        </p:nvSpPr>
        <p:spPr>
          <a:xfrm>
            <a:off x="3487680" y="1751040"/>
            <a:ext cx="26780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맑은 고딕"/>
              </a:rPr>
              <a:t>Probe quality filtering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맑은 고딕"/>
              </a:rPr>
              <a:t>Quantile normalization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맑은 고딕"/>
              </a:rPr>
              <a:t>Data transformation (Avg_beta value, M value, Log2(Avg_beta) value)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cxnSp>
        <p:nvCxnSpPr>
          <p:cNvPr id="60" name="직선 화살표 연결선 14"/>
          <p:cNvCxnSpPr>
            <a:stCxn id="57" idx="2"/>
            <a:endCxn id="61" idx="0"/>
          </p:cNvCxnSpPr>
          <p:nvPr/>
        </p:nvCxnSpPr>
        <p:spPr>
          <a:xfrm>
            <a:off x="3537720" y="1751040"/>
            <a:ext cx="360" cy="61452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2" name="직선 화살표 연결선 16"/>
          <p:cNvCxnSpPr>
            <a:stCxn id="61" idx="2"/>
            <a:endCxn id="63" idx="0"/>
          </p:cNvCxnSpPr>
          <p:nvPr/>
        </p:nvCxnSpPr>
        <p:spPr>
          <a:xfrm>
            <a:off x="3537720" y="2654280"/>
            <a:ext cx="360" cy="33552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4" name="직선 화살표 연결선 18"/>
          <p:cNvCxnSpPr>
            <a:stCxn id="65" idx="2"/>
            <a:endCxn id="66" idx="0"/>
          </p:cNvCxnSpPr>
          <p:nvPr/>
        </p:nvCxnSpPr>
        <p:spPr>
          <a:xfrm>
            <a:off x="3537720" y="7234200"/>
            <a:ext cx="360" cy="16236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3" name="직사각형 25"/>
          <p:cNvSpPr/>
          <p:nvPr/>
        </p:nvSpPr>
        <p:spPr>
          <a:xfrm>
            <a:off x="2278080" y="2989440"/>
            <a:ext cx="2519280" cy="2872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Reliable probes  (359,228)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cxnSp>
        <p:nvCxnSpPr>
          <p:cNvPr id="67" name="직선 화살표 연결선 28"/>
          <p:cNvCxnSpPr>
            <a:stCxn id="63" idx="2"/>
            <a:endCxn id="68" idx="0"/>
          </p:cNvCxnSpPr>
          <p:nvPr/>
        </p:nvCxnSpPr>
        <p:spPr>
          <a:xfrm>
            <a:off x="3537720" y="3276720"/>
            <a:ext cx="360" cy="24804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1" name="직사각형 32"/>
          <p:cNvSpPr/>
          <p:nvPr/>
        </p:nvSpPr>
        <p:spPr>
          <a:xfrm>
            <a:off x="2278080" y="2365200"/>
            <a:ext cx="2519280" cy="2890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Mock vs. 5-aza-dC, 2Gy, 5Gy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9" name="TextBox 12"/>
          <p:cNvSpPr/>
          <p:nvPr/>
        </p:nvSpPr>
        <p:spPr>
          <a:xfrm>
            <a:off x="3487680" y="2658960"/>
            <a:ext cx="2678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맑은 고딕"/>
              </a:rPr>
              <a:t>|deltal_mean|&gt;=0.2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맑은 고딕"/>
              </a:rPr>
              <a:t>Mock normalization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5" name="직사각형 44"/>
          <p:cNvSpPr/>
          <p:nvPr/>
        </p:nvSpPr>
        <p:spPr>
          <a:xfrm>
            <a:off x="2278080" y="6946920"/>
            <a:ext cx="2519280" cy="2872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ChIP assay / qMSP (6 / 3 genes)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cxnSp>
        <p:nvCxnSpPr>
          <p:cNvPr id="70" name="직선 화살표 연결선 48"/>
          <p:cNvCxnSpPr>
            <a:stCxn id="58" idx="2"/>
            <a:endCxn id="65" idx="0"/>
          </p:cNvCxnSpPr>
          <p:nvPr/>
        </p:nvCxnSpPr>
        <p:spPr>
          <a:xfrm>
            <a:off x="3537720" y="6784920"/>
            <a:ext cx="360" cy="16236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8" name="직사각형 33"/>
          <p:cNvSpPr/>
          <p:nvPr/>
        </p:nvSpPr>
        <p:spPr>
          <a:xfrm>
            <a:off x="2925720" y="3524400"/>
            <a:ext cx="1224000" cy="2872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Mock vs. 5-aza-dC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4,675 probe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1" name="직사각형 40"/>
          <p:cNvSpPr/>
          <p:nvPr/>
        </p:nvSpPr>
        <p:spPr>
          <a:xfrm>
            <a:off x="1557360" y="3524400"/>
            <a:ext cx="1222200" cy="2872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Mock vs. 2Gy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89 probe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2" name="직사각형 42"/>
          <p:cNvSpPr/>
          <p:nvPr/>
        </p:nvSpPr>
        <p:spPr>
          <a:xfrm>
            <a:off x="4294080" y="3524400"/>
            <a:ext cx="1224000" cy="2872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Mock vs. 5Gy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71 probe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3" name="직선 연결선 51"/>
          <p:cNvSpPr/>
          <p:nvPr/>
        </p:nvSpPr>
        <p:spPr>
          <a:xfrm>
            <a:off x="2168640" y="3370320"/>
            <a:ext cx="0" cy="14292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4" name="직선 연결선 52"/>
          <p:cNvSpPr/>
          <p:nvPr/>
        </p:nvSpPr>
        <p:spPr>
          <a:xfrm>
            <a:off x="4905360" y="3370320"/>
            <a:ext cx="0" cy="14292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5" name="직선 연결선 60"/>
          <p:cNvSpPr/>
          <p:nvPr/>
        </p:nvSpPr>
        <p:spPr>
          <a:xfrm>
            <a:off x="2166840" y="3373560"/>
            <a:ext cx="2737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6" name="직사각형 63"/>
          <p:cNvSpPr/>
          <p:nvPr/>
        </p:nvSpPr>
        <p:spPr>
          <a:xfrm>
            <a:off x="2120760" y="4067280"/>
            <a:ext cx="1368720" cy="2872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25 probes (16 genes)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7" name="직사각형 64"/>
          <p:cNvSpPr/>
          <p:nvPr/>
        </p:nvSpPr>
        <p:spPr>
          <a:xfrm>
            <a:off x="3592440" y="4067280"/>
            <a:ext cx="1368360" cy="2872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21 probes (15 genes)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8" name="직선 연결선 75"/>
          <p:cNvSpPr/>
          <p:nvPr/>
        </p:nvSpPr>
        <p:spPr>
          <a:xfrm>
            <a:off x="2168640" y="3814920"/>
            <a:ext cx="0" cy="10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9" name="직선 연결선 76"/>
          <p:cNvSpPr/>
          <p:nvPr/>
        </p:nvSpPr>
        <p:spPr>
          <a:xfrm>
            <a:off x="3429000" y="3814920"/>
            <a:ext cx="0" cy="10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0" name="직선 연결선 77"/>
          <p:cNvSpPr/>
          <p:nvPr/>
        </p:nvSpPr>
        <p:spPr>
          <a:xfrm>
            <a:off x="4905360" y="3814920"/>
            <a:ext cx="0" cy="10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1" name="직선 연결선 79"/>
          <p:cNvSpPr/>
          <p:nvPr/>
        </p:nvSpPr>
        <p:spPr>
          <a:xfrm>
            <a:off x="3645000" y="3814920"/>
            <a:ext cx="0" cy="10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2" name="직선 연결선 81"/>
          <p:cNvSpPr/>
          <p:nvPr/>
        </p:nvSpPr>
        <p:spPr>
          <a:xfrm>
            <a:off x="2174760" y="3919680"/>
            <a:ext cx="1260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3" name="직선 연결선 82"/>
          <p:cNvSpPr/>
          <p:nvPr/>
        </p:nvSpPr>
        <p:spPr>
          <a:xfrm>
            <a:off x="3646440" y="3919680"/>
            <a:ext cx="1260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4" name="직선 연결선 85"/>
          <p:cNvSpPr/>
          <p:nvPr/>
        </p:nvSpPr>
        <p:spPr>
          <a:xfrm>
            <a:off x="2805120" y="3916440"/>
            <a:ext cx="0" cy="14436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5" name="직선 연결선 86"/>
          <p:cNvSpPr/>
          <p:nvPr/>
        </p:nvSpPr>
        <p:spPr>
          <a:xfrm>
            <a:off x="4276800" y="3916440"/>
            <a:ext cx="0" cy="14436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6" name="직선 연결선 89"/>
          <p:cNvSpPr/>
          <p:nvPr/>
        </p:nvSpPr>
        <p:spPr>
          <a:xfrm>
            <a:off x="2805120" y="4362480"/>
            <a:ext cx="0" cy="1080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7" name="직선 연결선 90"/>
          <p:cNvSpPr/>
          <p:nvPr/>
        </p:nvSpPr>
        <p:spPr>
          <a:xfrm>
            <a:off x="4276800" y="4362480"/>
            <a:ext cx="0" cy="1080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8" name="직선 연결선 91"/>
          <p:cNvSpPr/>
          <p:nvPr/>
        </p:nvSpPr>
        <p:spPr>
          <a:xfrm>
            <a:off x="2803680" y="4464000"/>
            <a:ext cx="1476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9" name="직선 연결선 92"/>
          <p:cNvSpPr/>
          <p:nvPr/>
        </p:nvSpPr>
        <p:spPr>
          <a:xfrm>
            <a:off x="3537000" y="4467240"/>
            <a:ext cx="0" cy="14436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grpSp>
        <p:nvGrpSpPr>
          <p:cNvPr id="90" name="그룹 87"/>
          <p:cNvGrpSpPr/>
          <p:nvPr/>
        </p:nvGrpSpPr>
        <p:grpSpPr>
          <a:xfrm>
            <a:off x="2313000" y="4594320"/>
            <a:ext cx="2446200" cy="1744560"/>
            <a:chOff x="2313000" y="4594320"/>
            <a:chExt cx="2446200" cy="1744560"/>
          </a:xfrm>
        </p:grpSpPr>
        <p:sp>
          <p:nvSpPr>
            <p:cNvPr id="91" name="직사각형 104"/>
            <p:cNvSpPr/>
            <p:nvPr/>
          </p:nvSpPr>
          <p:spPr>
            <a:xfrm>
              <a:off x="2313000" y="4620960"/>
              <a:ext cx="2446200" cy="17179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grpSp>
          <p:nvGrpSpPr>
            <p:cNvPr id="92" name="그룹 101"/>
            <p:cNvGrpSpPr/>
            <p:nvPr/>
          </p:nvGrpSpPr>
          <p:grpSpPr>
            <a:xfrm>
              <a:off x="2361960" y="4594320"/>
              <a:ext cx="2347920" cy="1706760"/>
              <a:chOff x="2361960" y="4594320"/>
              <a:chExt cx="2347920" cy="1706760"/>
            </a:xfrm>
          </p:grpSpPr>
          <p:sp>
            <p:nvSpPr>
              <p:cNvPr id="93" name="타원 94"/>
              <p:cNvSpPr/>
              <p:nvPr/>
            </p:nvSpPr>
            <p:spPr>
              <a:xfrm>
                <a:off x="2361960" y="4776840"/>
                <a:ext cx="1523880" cy="1524240"/>
              </a:xfrm>
              <a:prstGeom prst="ellipse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4" name="타원 95"/>
              <p:cNvSpPr/>
              <p:nvPr/>
            </p:nvSpPr>
            <p:spPr>
              <a:xfrm>
                <a:off x="3186000" y="4776840"/>
                <a:ext cx="1523880" cy="1524240"/>
              </a:xfrm>
              <a:prstGeom prst="ellipse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5" name="TextBox 96"/>
              <p:cNvSpPr/>
              <p:nvPr/>
            </p:nvSpPr>
            <p:spPr>
              <a:xfrm>
                <a:off x="3211560" y="5166000"/>
                <a:ext cx="648720" cy="839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APBB2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C10orf140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CTGF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 </a:t>
                </a: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LBR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TSPY1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TSPY4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ZSWIM5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6" name="TextBox 97"/>
              <p:cNvSpPr/>
              <p:nvPr/>
            </p:nvSpPr>
            <p:spPr>
              <a:xfrm>
                <a:off x="2511000" y="4902120"/>
                <a:ext cx="648720" cy="1266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ANGPT1</a:t>
                </a:r>
                <a:r>
                  <a:rPr b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 </a:t>
                </a: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CASC1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IGLON5</a:t>
                </a:r>
                <a:r>
                  <a:rPr b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 </a:t>
                </a: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LMAN1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LYRM5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PLCL2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RASAL1</a:t>
                </a:r>
                <a:r>
                  <a:rPr b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 </a:t>
                </a: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SLC43A2</a:t>
                </a:r>
                <a:r>
                  <a:rPr b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SP1</a:t>
                </a:r>
                <a:r>
                  <a:rPr b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TCERG1L</a:t>
                </a:r>
                <a:r>
                  <a:rPr b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 </a:t>
                </a: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ZNF69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7" name="TextBox 98"/>
              <p:cNvSpPr/>
              <p:nvPr/>
            </p:nvSpPr>
            <p:spPr>
              <a:xfrm>
                <a:off x="3911760" y="4932000"/>
                <a:ext cx="648720" cy="1266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ATP5A1</a:t>
                </a:r>
                <a:r>
                  <a:rPr b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 </a:t>
                </a: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C10orf4</a:t>
                </a:r>
                <a:r>
                  <a:rPr b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CHGA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CXADRP2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HAUS1</a:t>
                </a:r>
                <a:r>
                  <a:rPr b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IFI16</a:t>
                </a:r>
                <a:r>
                  <a:rPr b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 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MCOLN1</a:t>
                </a:r>
                <a:r>
                  <a:rPr b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 </a:t>
                </a: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MTMR8</a:t>
                </a:r>
                <a:r>
                  <a:rPr b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 </a:t>
                </a: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PDZRN3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PLEKHM2</a:t>
                </a:r>
                <a:r>
                  <a:rPr b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 </a:t>
                </a:r>
                <a:r>
                  <a:rPr b="1" i="1" lang="en-US" sz="7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ZNF175</a:t>
                </a:r>
                <a:endParaRPr b="0" lang="en-US" sz="7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8" name="TextBox 99"/>
              <p:cNvSpPr/>
              <p:nvPr/>
            </p:nvSpPr>
            <p:spPr>
              <a:xfrm>
                <a:off x="2815200" y="4594320"/>
                <a:ext cx="535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2Gy</a:t>
                </a:r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9" name="TextBox 100"/>
              <p:cNvSpPr/>
              <p:nvPr/>
            </p:nvSpPr>
            <p:spPr>
              <a:xfrm>
                <a:off x="3679920" y="4594320"/>
                <a:ext cx="535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Calibri"/>
                    <a:ea typeface="굴림"/>
                  </a:rPr>
                  <a:t>5Gy</a:t>
                </a:r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</p:grpSp>
      <p:sp>
        <p:nvSpPr>
          <p:cNvPr id="100" name="TextBox 50"/>
          <p:cNvSpPr/>
          <p:nvPr/>
        </p:nvSpPr>
        <p:spPr>
          <a:xfrm rot="16200000">
            <a:off x="547560" y="2779200"/>
            <a:ext cx="1089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굴림"/>
              </a:rPr>
              <a:t>Discovery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1" name="TextBox 53"/>
          <p:cNvSpPr/>
          <p:nvPr/>
        </p:nvSpPr>
        <p:spPr>
          <a:xfrm rot="16200000">
            <a:off x="547560" y="6968520"/>
            <a:ext cx="1089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굴림"/>
              </a:rPr>
              <a:t>Validation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2" name="TextBox 67"/>
          <p:cNvSpPr/>
          <p:nvPr/>
        </p:nvSpPr>
        <p:spPr>
          <a:xfrm rot="16200000">
            <a:off x="547560" y="5336640"/>
            <a:ext cx="1089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굴림"/>
              </a:rPr>
              <a:t>Candidates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3" name="직선 연결선 69"/>
          <p:cNvSpPr/>
          <p:nvPr/>
        </p:nvSpPr>
        <p:spPr>
          <a:xfrm>
            <a:off x="3537000" y="6338880"/>
            <a:ext cx="0" cy="15876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6" name="직사각형 78"/>
          <p:cNvSpPr/>
          <p:nvPr/>
        </p:nvSpPr>
        <p:spPr>
          <a:xfrm>
            <a:off x="2278080" y="7396200"/>
            <a:ext cx="2519280" cy="2872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Final genes (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ANGPT1, APBB2, CHGA, CTGF, IGLON5, SLC43A2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4" name="TextBox 26"/>
          <p:cNvSpPr/>
          <p:nvPr/>
        </p:nvSpPr>
        <p:spPr>
          <a:xfrm>
            <a:off x="0" y="0"/>
            <a:ext cx="1893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굴림"/>
              </a:rPr>
              <a:t>Figure S1. Bae et al.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5" name="그룹 89"/>
          <p:cNvGrpSpPr/>
          <p:nvPr/>
        </p:nvGrpSpPr>
        <p:grpSpPr>
          <a:xfrm>
            <a:off x="139680" y="1411200"/>
            <a:ext cx="6585120" cy="1471680"/>
            <a:chOff x="139680" y="1411200"/>
            <a:chExt cx="6585120" cy="1471680"/>
          </a:xfrm>
        </p:grpSpPr>
        <p:pic>
          <p:nvPicPr>
            <p:cNvPr id="106" name="차트 88" descr=""/>
            <p:cNvPicPr/>
            <p:nvPr/>
          </p:nvPicPr>
          <p:blipFill>
            <a:blip r:embed="rId1"/>
            <a:stretch/>
          </p:blipFill>
          <p:spPr>
            <a:xfrm>
              <a:off x="139680" y="1411200"/>
              <a:ext cx="6529680" cy="1441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7" name="직사각형 89"/>
            <p:cNvSpPr/>
            <p:nvPr/>
          </p:nvSpPr>
          <p:spPr>
            <a:xfrm>
              <a:off x="170640" y="2567880"/>
              <a:ext cx="6554160" cy="315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8" name="직사각형 90"/>
            <p:cNvSpPr/>
            <p:nvPr/>
          </p:nvSpPr>
          <p:spPr>
            <a:xfrm>
              <a:off x="6220080" y="1914120"/>
              <a:ext cx="504720" cy="814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9" name="직사각형 91"/>
            <p:cNvSpPr/>
            <p:nvPr/>
          </p:nvSpPr>
          <p:spPr>
            <a:xfrm>
              <a:off x="183600" y="2523600"/>
              <a:ext cx="215640" cy="315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grpSp>
        <p:nvGrpSpPr>
          <p:cNvPr id="110" name="그룹 152"/>
          <p:cNvGrpSpPr/>
          <p:nvPr/>
        </p:nvGrpSpPr>
        <p:grpSpPr>
          <a:xfrm>
            <a:off x="106200" y="7257960"/>
            <a:ext cx="2821320" cy="1596960"/>
            <a:chOff x="106200" y="7257960"/>
            <a:chExt cx="2821320" cy="1596960"/>
          </a:xfrm>
        </p:grpSpPr>
        <p:pic>
          <p:nvPicPr>
            <p:cNvPr id="111" name="차트 93" descr=""/>
            <p:cNvPicPr/>
            <p:nvPr/>
          </p:nvPicPr>
          <p:blipFill>
            <a:blip r:embed="rId2"/>
            <a:stretch/>
          </p:blipFill>
          <p:spPr>
            <a:xfrm>
              <a:off x="106200" y="7257960"/>
              <a:ext cx="2821320" cy="14414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12" name="그룹 35"/>
            <p:cNvGrpSpPr/>
            <p:nvPr/>
          </p:nvGrpSpPr>
          <p:grpSpPr>
            <a:xfrm>
              <a:off x="177480" y="7274160"/>
              <a:ext cx="2738160" cy="1580760"/>
              <a:chOff x="177480" y="7274160"/>
              <a:chExt cx="2738160" cy="1580760"/>
            </a:xfrm>
          </p:grpSpPr>
          <p:sp>
            <p:nvSpPr>
              <p:cNvPr id="113" name="직사각형 95"/>
              <p:cNvSpPr/>
              <p:nvPr/>
            </p:nvSpPr>
            <p:spPr>
              <a:xfrm>
                <a:off x="177480" y="7777800"/>
                <a:ext cx="2738160" cy="1077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14" name="직사각형 96"/>
              <p:cNvSpPr/>
              <p:nvPr/>
            </p:nvSpPr>
            <p:spPr>
              <a:xfrm>
                <a:off x="2396880" y="7274160"/>
                <a:ext cx="518760" cy="15807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</p:grpSp>
      <p:grpSp>
        <p:nvGrpSpPr>
          <p:cNvPr id="115" name="그룹 132"/>
          <p:cNvGrpSpPr/>
          <p:nvPr/>
        </p:nvGrpSpPr>
        <p:grpSpPr>
          <a:xfrm>
            <a:off x="115920" y="3648240"/>
            <a:ext cx="6553080" cy="1584000"/>
            <a:chOff x="115920" y="3648240"/>
            <a:chExt cx="6553080" cy="1584000"/>
          </a:xfrm>
        </p:grpSpPr>
        <p:pic>
          <p:nvPicPr>
            <p:cNvPr id="116" name="차트 98" descr=""/>
            <p:cNvPicPr/>
            <p:nvPr/>
          </p:nvPicPr>
          <p:blipFill>
            <a:blip r:embed="rId3"/>
            <a:stretch/>
          </p:blipFill>
          <p:spPr>
            <a:xfrm>
              <a:off x="121680" y="3648240"/>
              <a:ext cx="6547320" cy="1442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7" name="직사각형 99"/>
            <p:cNvSpPr/>
            <p:nvPr/>
          </p:nvSpPr>
          <p:spPr>
            <a:xfrm>
              <a:off x="115920" y="4656960"/>
              <a:ext cx="6553080" cy="575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8" name="직사각형 100"/>
            <p:cNvSpPr/>
            <p:nvPr/>
          </p:nvSpPr>
          <p:spPr>
            <a:xfrm>
              <a:off x="6021360" y="3722040"/>
              <a:ext cx="647640" cy="1510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pic>
        <p:nvPicPr>
          <p:cNvPr id="119" name="차트 101" descr=""/>
          <p:cNvPicPr/>
          <p:nvPr/>
        </p:nvPicPr>
        <p:blipFill>
          <a:blip r:embed="rId4"/>
          <a:stretch/>
        </p:blipFill>
        <p:spPr>
          <a:xfrm>
            <a:off x="182520" y="2139840"/>
            <a:ext cx="6486480" cy="1438560"/>
          </a:xfrm>
          <a:prstGeom prst="rect">
            <a:avLst/>
          </a:prstGeom>
          <a:ln w="0">
            <a:noFill/>
          </a:ln>
        </p:spPr>
      </p:pic>
      <p:sp>
        <p:nvSpPr>
          <p:cNvPr id="120" name="TextBox 58"/>
          <p:cNvSpPr/>
          <p:nvPr/>
        </p:nvSpPr>
        <p:spPr>
          <a:xfrm>
            <a:off x="316080" y="2268360"/>
            <a:ext cx="610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CHGA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1" name="TextBox 59"/>
          <p:cNvSpPr/>
          <p:nvPr/>
        </p:nvSpPr>
        <p:spPr>
          <a:xfrm>
            <a:off x="1596960" y="2268360"/>
            <a:ext cx="61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CTGF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2" name="TextBox 60"/>
          <p:cNvSpPr/>
          <p:nvPr/>
        </p:nvSpPr>
        <p:spPr>
          <a:xfrm>
            <a:off x="2587680" y="2268360"/>
            <a:ext cx="611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HAUS1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3" name="TextBox 61"/>
          <p:cNvSpPr/>
          <p:nvPr/>
        </p:nvSpPr>
        <p:spPr>
          <a:xfrm>
            <a:off x="3522600" y="2268360"/>
            <a:ext cx="61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IFI16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4" name="TextBox 62"/>
          <p:cNvSpPr/>
          <p:nvPr/>
        </p:nvSpPr>
        <p:spPr>
          <a:xfrm>
            <a:off x="4459320" y="2268360"/>
            <a:ext cx="61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IGLON5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5" name="TextBox 63"/>
          <p:cNvSpPr/>
          <p:nvPr/>
        </p:nvSpPr>
        <p:spPr>
          <a:xfrm>
            <a:off x="5484960" y="2268360"/>
            <a:ext cx="61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LBR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126" name="차트 108" descr=""/>
          <p:cNvPicPr/>
          <p:nvPr/>
        </p:nvPicPr>
        <p:blipFill>
          <a:blip r:embed="rId5"/>
          <a:stretch/>
        </p:blipFill>
        <p:spPr>
          <a:xfrm>
            <a:off x="182520" y="469800"/>
            <a:ext cx="6486480" cy="1438200"/>
          </a:xfrm>
          <a:prstGeom prst="rect">
            <a:avLst/>
          </a:prstGeom>
          <a:ln w="0">
            <a:noFill/>
          </a:ln>
        </p:spPr>
      </p:pic>
      <p:sp>
        <p:nvSpPr>
          <p:cNvPr id="127" name="TextBox 64"/>
          <p:cNvSpPr/>
          <p:nvPr/>
        </p:nvSpPr>
        <p:spPr>
          <a:xfrm>
            <a:off x="517680" y="558720"/>
            <a:ext cx="61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ANGPT1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8" name="TextBox 65"/>
          <p:cNvSpPr/>
          <p:nvPr/>
        </p:nvSpPr>
        <p:spPr>
          <a:xfrm>
            <a:off x="1552680" y="558720"/>
            <a:ext cx="610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APBB2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9" name="TextBox 66"/>
          <p:cNvSpPr/>
          <p:nvPr/>
        </p:nvSpPr>
        <p:spPr>
          <a:xfrm>
            <a:off x="2587680" y="558720"/>
            <a:ext cx="611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ATP5A1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0" name="TextBox 67"/>
          <p:cNvSpPr/>
          <p:nvPr/>
        </p:nvSpPr>
        <p:spPr>
          <a:xfrm>
            <a:off x="3632040" y="558720"/>
            <a:ext cx="613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C10orf140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1" name="TextBox 68"/>
          <p:cNvSpPr/>
          <p:nvPr/>
        </p:nvSpPr>
        <p:spPr>
          <a:xfrm>
            <a:off x="4675320" y="558720"/>
            <a:ext cx="61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C10orf4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2" name="TextBox 69"/>
          <p:cNvSpPr/>
          <p:nvPr/>
        </p:nvSpPr>
        <p:spPr>
          <a:xfrm>
            <a:off x="5611680" y="558720"/>
            <a:ext cx="611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CASC1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3" name="TextBox 76"/>
          <p:cNvSpPr/>
          <p:nvPr/>
        </p:nvSpPr>
        <p:spPr>
          <a:xfrm>
            <a:off x="547560" y="3975120"/>
            <a:ext cx="613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LMAN1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4" name="TextBox 77"/>
          <p:cNvSpPr/>
          <p:nvPr/>
        </p:nvSpPr>
        <p:spPr>
          <a:xfrm>
            <a:off x="1563840" y="3975120"/>
            <a:ext cx="61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LYRM5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5" name="TextBox 78"/>
          <p:cNvSpPr/>
          <p:nvPr/>
        </p:nvSpPr>
        <p:spPr>
          <a:xfrm>
            <a:off x="2563920" y="3975120"/>
            <a:ext cx="61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MCOLN1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6" name="TextBox 79"/>
          <p:cNvSpPr/>
          <p:nvPr/>
        </p:nvSpPr>
        <p:spPr>
          <a:xfrm>
            <a:off x="3560760" y="3975120"/>
            <a:ext cx="61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MTMR8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7" name="TextBox 80"/>
          <p:cNvSpPr/>
          <p:nvPr/>
        </p:nvSpPr>
        <p:spPr>
          <a:xfrm>
            <a:off x="4573440" y="3975120"/>
            <a:ext cx="611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PDZRN3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8" name="TextBox 70"/>
          <p:cNvSpPr/>
          <p:nvPr/>
        </p:nvSpPr>
        <p:spPr>
          <a:xfrm>
            <a:off x="547560" y="5621400"/>
            <a:ext cx="613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PLEKHM2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9" name="TextBox 71"/>
          <p:cNvSpPr/>
          <p:nvPr/>
        </p:nvSpPr>
        <p:spPr>
          <a:xfrm>
            <a:off x="1563840" y="5621400"/>
            <a:ext cx="61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RASAL1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0" name="TextBox 72"/>
          <p:cNvSpPr/>
          <p:nvPr/>
        </p:nvSpPr>
        <p:spPr>
          <a:xfrm>
            <a:off x="2563920" y="5621400"/>
            <a:ext cx="61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SLC43A2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1" name="TextBox 73"/>
          <p:cNvSpPr/>
          <p:nvPr/>
        </p:nvSpPr>
        <p:spPr>
          <a:xfrm>
            <a:off x="3560760" y="5621400"/>
            <a:ext cx="61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SP1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2" name="TextBox 74"/>
          <p:cNvSpPr/>
          <p:nvPr/>
        </p:nvSpPr>
        <p:spPr>
          <a:xfrm>
            <a:off x="4573440" y="5621400"/>
            <a:ext cx="611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TCERG1L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3" name="TextBox 75"/>
          <p:cNvSpPr/>
          <p:nvPr/>
        </p:nvSpPr>
        <p:spPr>
          <a:xfrm>
            <a:off x="5573880" y="5621400"/>
            <a:ext cx="610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ZNF175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144" name="차트 127" descr=""/>
          <p:cNvPicPr/>
          <p:nvPr/>
        </p:nvPicPr>
        <p:blipFill>
          <a:blip r:embed="rId6"/>
          <a:stretch/>
        </p:blipFill>
        <p:spPr>
          <a:xfrm>
            <a:off x="182520" y="5546880"/>
            <a:ext cx="6486480" cy="1439640"/>
          </a:xfrm>
          <a:prstGeom prst="rect">
            <a:avLst/>
          </a:prstGeom>
          <a:ln w="0">
            <a:noFill/>
          </a:ln>
        </p:spPr>
      </p:pic>
      <p:pic>
        <p:nvPicPr>
          <p:cNvPr id="145" name="차트 128" descr=""/>
          <p:cNvPicPr/>
          <p:nvPr/>
        </p:nvPicPr>
        <p:blipFill>
          <a:blip r:embed="rId7"/>
          <a:stretch/>
        </p:blipFill>
        <p:spPr>
          <a:xfrm>
            <a:off x="182520" y="7338960"/>
            <a:ext cx="2743200" cy="1444680"/>
          </a:xfrm>
          <a:prstGeom prst="rect">
            <a:avLst/>
          </a:prstGeom>
          <a:ln w="0">
            <a:noFill/>
          </a:ln>
        </p:spPr>
      </p:pic>
      <p:sp>
        <p:nvSpPr>
          <p:cNvPr id="146" name="TextBox 100"/>
          <p:cNvSpPr/>
          <p:nvPr/>
        </p:nvSpPr>
        <p:spPr>
          <a:xfrm rot="16200000">
            <a:off x="-779760" y="1004040"/>
            <a:ext cx="18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Expression fold change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7" name="TextBox 101"/>
          <p:cNvSpPr/>
          <p:nvPr/>
        </p:nvSpPr>
        <p:spPr>
          <a:xfrm rot="16200000">
            <a:off x="5747400" y="1005120"/>
            <a:ext cx="180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Methylation fold change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8" name="TextBox 102"/>
          <p:cNvSpPr/>
          <p:nvPr/>
        </p:nvSpPr>
        <p:spPr>
          <a:xfrm rot="16200000">
            <a:off x="-780120" y="2540160"/>
            <a:ext cx="180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Expression fold change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9" name="TextBox 103"/>
          <p:cNvSpPr/>
          <p:nvPr/>
        </p:nvSpPr>
        <p:spPr>
          <a:xfrm rot="16200000">
            <a:off x="5747400" y="2684520"/>
            <a:ext cx="180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Methylation fold change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0" name="TextBox 106"/>
          <p:cNvSpPr/>
          <p:nvPr/>
        </p:nvSpPr>
        <p:spPr>
          <a:xfrm rot="16200000">
            <a:off x="-780120" y="6043680"/>
            <a:ext cx="180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Expression fold change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1" name="TextBox 107"/>
          <p:cNvSpPr/>
          <p:nvPr/>
        </p:nvSpPr>
        <p:spPr>
          <a:xfrm rot="16200000">
            <a:off x="5747400" y="6069240"/>
            <a:ext cx="180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Methylation fold change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2" name="TextBox 108"/>
          <p:cNvSpPr/>
          <p:nvPr/>
        </p:nvSpPr>
        <p:spPr>
          <a:xfrm rot="16200000">
            <a:off x="-779760" y="7831800"/>
            <a:ext cx="18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Expression fold change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3" name="TextBox 109"/>
          <p:cNvSpPr/>
          <p:nvPr/>
        </p:nvSpPr>
        <p:spPr>
          <a:xfrm rot="16200000">
            <a:off x="2004480" y="7869960"/>
            <a:ext cx="18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Methylation fold change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4" name="TextBox 82"/>
          <p:cNvSpPr/>
          <p:nvPr/>
        </p:nvSpPr>
        <p:spPr>
          <a:xfrm>
            <a:off x="290520" y="7607160"/>
            <a:ext cx="61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ZNF69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5" name="TextBox 83"/>
          <p:cNvSpPr/>
          <p:nvPr/>
        </p:nvSpPr>
        <p:spPr>
          <a:xfrm>
            <a:off x="1704960" y="7607160"/>
            <a:ext cx="61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ZSWIM5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6" name="TextBox 87"/>
          <p:cNvSpPr/>
          <p:nvPr/>
        </p:nvSpPr>
        <p:spPr>
          <a:xfrm>
            <a:off x="5373720" y="3975120"/>
            <a:ext cx="611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alibri"/>
                <a:ea typeface="맑은 고딕"/>
              </a:rPr>
              <a:t>PLCL2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7" name="직사각형 150"/>
          <p:cNvSpPr/>
          <p:nvPr/>
        </p:nvSpPr>
        <p:spPr>
          <a:xfrm>
            <a:off x="201600" y="3851280"/>
            <a:ext cx="7308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8" name="TextBox 105"/>
          <p:cNvSpPr/>
          <p:nvPr/>
        </p:nvSpPr>
        <p:spPr>
          <a:xfrm rot="16200000">
            <a:off x="5747760" y="4375800"/>
            <a:ext cx="18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Methylation fold change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9" name="TextBox 104"/>
          <p:cNvSpPr/>
          <p:nvPr/>
        </p:nvSpPr>
        <p:spPr>
          <a:xfrm rot="16200000">
            <a:off x="-780120" y="4280040"/>
            <a:ext cx="180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맑은 고딕"/>
              </a:rPr>
              <a:t>Expression fold change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160" name="차트 154" descr=""/>
          <p:cNvPicPr/>
          <p:nvPr/>
        </p:nvPicPr>
        <p:blipFill>
          <a:blip r:embed="rId8"/>
          <a:stretch/>
        </p:blipFill>
        <p:spPr>
          <a:xfrm>
            <a:off x="182520" y="3809880"/>
            <a:ext cx="6486480" cy="1444680"/>
          </a:xfrm>
          <a:prstGeom prst="rect">
            <a:avLst/>
          </a:prstGeom>
          <a:ln w="0">
            <a:noFill/>
          </a:ln>
        </p:spPr>
      </p:pic>
      <p:sp>
        <p:nvSpPr>
          <p:cNvPr id="161" name="순서도: 천공 테이프 161"/>
          <p:cNvSpPr/>
          <p:nvPr/>
        </p:nvSpPr>
        <p:spPr>
          <a:xfrm>
            <a:off x="5811840" y="3913200"/>
            <a:ext cx="144360" cy="54000"/>
          </a:xfrm>
          <a:prstGeom prst="flowChartPunchedTap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400" bIns="-144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2" name="직사각형 165"/>
          <p:cNvSpPr/>
          <p:nvPr/>
        </p:nvSpPr>
        <p:spPr>
          <a:xfrm>
            <a:off x="5958000" y="3898800"/>
            <a:ext cx="46080" cy="716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3" name="직사각형 170"/>
          <p:cNvSpPr/>
          <p:nvPr/>
        </p:nvSpPr>
        <p:spPr>
          <a:xfrm>
            <a:off x="5764320" y="3902040"/>
            <a:ext cx="46080" cy="716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grpSp>
        <p:nvGrpSpPr>
          <p:cNvPr id="164" name="그룹 142"/>
          <p:cNvGrpSpPr/>
          <p:nvPr/>
        </p:nvGrpSpPr>
        <p:grpSpPr>
          <a:xfrm>
            <a:off x="318960" y="3898800"/>
            <a:ext cx="198720" cy="76320"/>
            <a:chOff x="318960" y="3898800"/>
            <a:chExt cx="198720" cy="76320"/>
          </a:xfrm>
        </p:grpSpPr>
        <p:sp>
          <p:nvSpPr>
            <p:cNvPr id="165" name="순서도: 천공 테이프 178"/>
            <p:cNvSpPr/>
            <p:nvPr/>
          </p:nvSpPr>
          <p:spPr>
            <a:xfrm>
              <a:off x="355320" y="3912840"/>
              <a:ext cx="125640" cy="54000"/>
            </a:xfrm>
            <a:prstGeom prst="flowChartPunchedTape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66" name="직사각형 182"/>
            <p:cNvSpPr/>
            <p:nvPr/>
          </p:nvSpPr>
          <p:spPr>
            <a:xfrm>
              <a:off x="471600" y="3898800"/>
              <a:ext cx="46080" cy="71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67" name="직사각형 183"/>
            <p:cNvSpPr/>
            <p:nvPr/>
          </p:nvSpPr>
          <p:spPr>
            <a:xfrm>
              <a:off x="318960" y="3903480"/>
              <a:ext cx="46080" cy="71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grpSp>
        <p:nvGrpSpPr>
          <p:cNvPr id="168" name="그룹 157"/>
          <p:cNvGrpSpPr/>
          <p:nvPr/>
        </p:nvGrpSpPr>
        <p:grpSpPr>
          <a:xfrm>
            <a:off x="324000" y="7507440"/>
            <a:ext cx="193680" cy="75960"/>
            <a:chOff x="324000" y="7507440"/>
            <a:chExt cx="193680" cy="75960"/>
          </a:xfrm>
        </p:grpSpPr>
        <p:sp>
          <p:nvSpPr>
            <p:cNvPr id="169" name="순서도: 천공 테이프 185"/>
            <p:cNvSpPr/>
            <p:nvPr/>
          </p:nvSpPr>
          <p:spPr>
            <a:xfrm>
              <a:off x="355680" y="7521480"/>
              <a:ext cx="125640" cy="54000"/>
            </a:xfrm>
            <a:prstGeom prst="flowChartPunchedTape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0" name="직사각형 186"/>
            <p:cNvSpPr/>
            <p:nvPr/>
          </p:nvSpPr>
          <p:spPr>
            <a:xfrm>
              <a:off x="471600" y="7507440"/>
              <a:ext cx="46080" cy="71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1" name="직사각형 187"/>
            <p:cNvSpPr/>
            <p:nvPr/>
          </p:nvSpPr>
          <p:spPr>
            <a:xfrm>
              <a:off x="324000" y="7512120"/>
              <a:ext cx="46080" cy="71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sp>
        <p:nvSpPr>
          <p:cNvPr id="172" name="순서도: 천공 테이프 189"/>
          <p:cNvSpPr/>
          <p:nvPr/>
        </p:nvSpPr>
        <p:spPr>
          <a:xfrm>
            <a:off x="733320" y="7521480"/>
            <a:ext cx="163440" cy="54000"/>
          </a:xfrm>
          <a:prstGeom prst="flowChartPunchedTap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400" bIns="-144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3" name="직사각형 190"/>
          <p:cNvSpPr/>
          <p:nvPr/>
        </p:nvSpPr>
        <p:spPr>
          <a:xfrm>
            <a:off x="887400" y="7507440"/>
            <a:ext cx="58680" cy="7128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4" name="직사각형 191"/>
          <p:cNvSpPr/>
          <p:nvPr/>
        </p:nvSpPr>
        <p:spPr>
          <a:xfrm>
            <a:off x="677880" y="7512120"/>
            <a:ext cx="58680" cy="7128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grpSp>
        <p:nvGrpSpPr>
          <p:cNvPr id="175" name="그룹 170"/>
          <p:cNvGrpSpPr/>
          <p:nvPr/>
        </p:nvGrpSpPr>
        <p:grpSpPr>
          <a:xfrm>
            <a:off x="378000" y="2465280"/>
            <a:ext cx="191880" cy="73080"/>
            <a:chOff x="378000" y="2465280"/>
            <a:chExt cx="191880" cy="73080"/>
          </a:xfrm>
        </p:grpSpPr>
        <p:sp>
          <p:nvSpPr>
            <p:cNvPr id="176" name="순서도: 천공 테이프 193"/>
            <p:cNvSpPr/>
            <p:nvPr/>
          </p:nvSpPr>
          <p:spPr>
            <a:xfrm>
              <a:off x="406440" y="2479320"/>
              <a:ext cx="127080" cy="52560"/>
            </a:xfrm>
            <a:prstGeom prst="flowChartPunchedTape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7" name="직사각형 194"/>
            <p:cNvSpPr/>
            <p:nvPr/>
          </p:nvSpPr>
          <p:spPr>
            <a:xfrm>
              <a:off x="524160" y="2465280"/>
              <a:ext cx="45720" cy="71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8" name="직사각형 195"/>
            <p:cNvSpPr/>
            <p:nvPr/>
          </p:nvSpPr>
          <p:spPr>
            <a:xfrm>
              <a:off x="378000" y="2466720"/>
              <a:ext cx="45720" cy="71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sp>
        <p:nvSpPr>
          <p:cNvPr id="179" name="순서도: 천공 테이프 197"/>
          <p:cNvSpPr/>
          <p:nvPr/>
        </p:nvSpPr>
        <p:spPr>
          <a:xfrm>
            <a:off x="749160" y="2479680"/>
            <a:ext cx="127080" cy="52560"/>
          </a:xfrm>
          <a:prstGeom prst="flowChartPunchedTap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0" name="직사각형 198"/>
          <p:cNvSpPr/>
          <p:nvPr/>
        </p:nvSpPr>
        <p:spPr>
          <a:xfrm>
            <a:off x="884160" y="2465280"/>
            <a:ext cx="46080" cy="716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1" name="직사각형 199"/>
          <p:cNvSpPr/>
          <p:nvPr/>
        </p:nvSpPr>
        <p:spPr>
          <a:xfrm>
            <a:off x="700200" y="2467080"/>
            <a:ext cx="46080" cy="7128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2" name="순서도: 천공 테이프 201"/>
          <p:cNvSpPr/>
          <p:nvPr/>
        </p:nvSpPr>
        <p:spPr>
          <a:xfrm>
            <a:off x="976320" y="2479680"/>
            <a:ext cx="144360" cy="52560"/>
          </a:xfrm>
          <a:prstGeom prst="flowChartPunchedTap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3" name="직사각형 202"/>
          <p:cNvSpPr/>
          <p:nvPr/>
        </p:nvSpPr>
        <p:spPr>
          <a:xfrm>
            <a:off x="1117440" y="2465280"/>
            <a:ext cx="46080" cy="716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4" name="직사각형 203"/>
          <p:cNvSpPr/>
          <p:nvPr/>
        </p:nvSpPr>
        <p:spPr>
          <a:xfrm>
            <a:off x="932040" y="2467080"/>
            <a:ext cx="45720" cy="7128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5" name="TextBox 26"/>
          <p:cNvSpPr/>
          <p:nvPr/>
        </p:nvSpPr>
        <p:spPr>
          <a:xfrm>
            <a:off x="0" y="0"/>
            <a:ext cx="1893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굴림"/>
              </a:rPr>
              <a:t>Figure S2. Bae et al.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6" name="그룹 6"/>
          <p:cNvGrpSpPr/>
          <p:nvPr/>
        </p:nvGrpSpPr>
        <p:grpSpPr>
          <a:xfrm>
            <a:off x="441360" y="250920"/>
            <a:ext cx="5975280" cy="5922720"/>
            <a:chOff x="441360" y="250920"/>
            <a:chExt cx="5975280" cy="5922720"/>
          </a:xfrm>
        </p:grpSpPr>
        <p:pic>
          <p:nvPicPr>
            <p:cNvPr id="187" name="Picture 3" descr=""/>
            <p:cNvPicPr/>
            <p:nvPr/>
          </p:nvPicPr>
          <p:blipFill>
            <a:blip r:embed="rId1"/>
            <a:srcRect l="15649" t="2009" r="15649" b="14109"/>
            <a:stretch/>
          </p:blipFill>
          <p:spPr>
            <a:xfrm>
              <a:off x="441360" y="250920"/>
              <a:ext cx="5975280" cy="5922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8" name="Picture 3" descr=""/>
            <p:cNvPicPr/>
            <p:nvPr/>
          </p:nvPicPr>
          <p:blipFill>
            <a:blip r:embed="rId2"/>
            <a:srcRect l="15649" t="89650" r="70129" b="2878"/>
            <a:stretch/>
          </p:blipFill>
          <p:spPr>
            <a:xfrm>
              <a:off x="441360" y="5378040"/>
              <a:ext cx="1236960" cy="5274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89" name="그룹 4"/>
          <p:cNvGrpSpPr/>
          <p:nvPr/>
        </p:nvGrpSpPr>
        <p:grpSpPr>
          <a:xfrm>
            <a:off x="3933720" y="4500720"/>
            <a:ext cx="1800360" cy="1401480"/>
            <a:chOff x="3933720" y="4500720"/>
            <a:chExt cx="1800360" cy="1401480"/>
          </a:xfrm>
        </p:grpSpPr>
        <p:pic>
          <p:nvPicPr>
            <p:cNvPr id="190" name="Picture 2" descr=""/>
            <p:cNvPicPr/>
            <p:nvPr/>
          </p:nvPicPr>
          <p:blipFill>
            <a:blip r:embed="rId3"/>
            <a:srcRect l="75851" t="20334" r="23432" b="68966"/>
            <a:stretch/>
          </p:blipFill>
          <p:spPr>
            <a:xfrm>
              <a:off x="3933720" y="4500720"/>
              <a:ext cx="131400" cy="1392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91" name="TextBox 6"/>
            <p:cNvSpPr/>
            <p:nvPr/>
          </p:nvSpPr>
          <p:spPr>
            <a:xfrm>
              <a:off x="4041720" y="4513680"/>
              <a:ext cx="1080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맑은 고딕"/>
                </a:rPr>
                <a:t>Co-expression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2" name="TextBox 7"/>
            <p:cNvSpPr/>
            <p:nvPr/>
          </p:nvSpPr>
          <p:spPr>
            <a:xfrm>
              <a:off x="4041720" y="4742280"/>
              <a:ext cx="1404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맑은 고딕"/>
                </a:rPr>
                <a:t>Physical interactions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3" name="TextBox 8"/>
            <p:cNvSpPr/>
            <p:nvPr/>
          </p:nvSpPr>
          <p:spPr>
            <a:xfrm>
              <a:off x="4041720" y="4970520"/>
              <a:ext cx="1080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맑은 고딕"/>
                </a:rPr>
                <a:t>Pathway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4" name="TextBox 9"/>
            <p:cNvSpPr/>
            <p:nvPr/>
          </p:nvSpPr>
          <p:spPr>
            <a:xfrm>
              <a:off x="4041720" y="5199120"/>
              <a:ext cx="1080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맑은 고딕"/>
                </a:rPr>
                <a:t>Co-localization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5" name="TextBox 10"/>
            <p:cNvSpPr/>
            <p:nvPr/>
          </p:nvSpPr>
          <p:spPr>
            <a:xfrm>
              <a:off x="4041720" y="5427360"/>
              <a:ext cx="169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맑은 고딕"/>
                </a:rPr>
                <a:t>Shared protein domains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6" name="TextBox 11"/>
            <p:cNvSpPr/>
            <p:nvPr/>
          </p:nvSpPr>
          <p:spPr>
            <a:xfrm>
              <a:off x="4041720" y="5655960"/>
              <a:ext cx="1548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맑은 고딕"/>
                </a:rPr>
                <a:t>Genetic interactions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graphicFrame>
        <p:nvGraphicFramePr>
          <p:cNvPr id="197" name=""/>
          <p:cNvGraphicFramePr/>
          <p:nvPr/>
        </p:nvGraphicFramePr>
        <p:xfrm>
          <a:off x="512640" y="6372360"/>
          <a:ext cx="5832720" cy="2368440"/>
        </p:xfrm>
        <a:graphic>
          <a:graphicData uri="http://schemas.openxmlformats.org/drawingml/2006/table">
            <a:tbl>
              <a:tblPr/>
              <a:tblGrid>
                <a:gridCol w="663840"/>
                <a:gridCol w="2073240"/>
                <a:gridCol w="718920"/>
                <a:gridCol w="2376720"/>
              </a:tblGrid>
              <a:tr h="158040"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맑은 고딕"/>
                        </a:rPr>
                        <a:t>Func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맑은 고딕"/>
                        </a:rPr>
                        <a:t>Descrip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맑은 고딕"/>
                        </a:rPr>
                        <a:t>GO ter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맑은 고딕"/>
                        </a:rPr>
                        <a:t>Related gene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 rowSpan="8"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맑은 고딕"/>
                        </a:rPr>
                        <a:t>Cell divis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pindle assembl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O:00512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맑은 고딕"/>
                        </a:rPr>
                        <a:t>HAUS1; HAUS2; HAUS3; HAUS4; HAUS5; HAUS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entrosome organiza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O:005129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맑은 고딕"/>
                        </a:rPr>
                        <a:t>HAUS1; HAUS2; HAUS3; HAUS4; HAUS5; HAUS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icrotubule organizing center organiza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O:00310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맑은 고딕"/>
                        </a:rPr>
                        <a:t>HAUS1; HAUS2; HAUS3; HAUS4; HAUS5; HAUS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pindle organiza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O:000705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맑은 고딕"/>
                        </a:rPr>
                        <a:t>HAUS1; HAUS2; HAUS3; HAUS4; HAUS5; HAUS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icrotubule associated complex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O:000587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맑은 고딕"/>
                        </a:rPr>
                        <a:t>HAUS1; HAUS2; HAUS3; HAUS4; HAUS5; HAUS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rganelle assembl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O:00709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맑은 고딕"/>
                        </a:rPr>
                        <a:t>HAUS1; HAUS2; HAUS3; HAUS4; HAUS5; HAUS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icrotubule cytoskeleton organiza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O:00002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맑은 고딕"/>
                        </a:rPr>
                        <a:t>HAUS1; HAUS2; HAUS3; HAUS4; HAUS5; HAUS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icrotubule-based proces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O:000701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맑은 고딕"/>
                        </a:rPr>
                        <a:t>HAUS1; HAUS2; HAUS3; HAUS4; HAUS5; HAUS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 rowSpan="3"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맑은 고딕"/>
                        </a:rPr>
                        <a:t>Vascular developmen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lomerulus vasculature developmen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O:00720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맑은 고딕"/>
                        </a:rPr>
                        <a:t>ANGPT1; ANGPT2; TEK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nal system vasculature developmen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O:006143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맑은 고딕"/>
                        </a:rPr>
                        <a:t>ANGPT1; ANGPT2; TEK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Kidney vasculature developmen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O:00614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맑은 고딕"/>
                        </a:rPr>
                        <a:t>ANGPT1; ANGPT2; TEK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 rowSpan="2"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맑은 고딕"/>
                        </a:rPr>
                        <a:t>Cell apoptosi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gulation of endothelial cell apoptotic proces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O:200035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맑은 고딕"/>
                        </a:rPr>
                        <a:t>ANGPT1; TEK; TNIP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ndothelial cell apoptotic proces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O:007257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맑은 고딕"/>
                        </a:rPr>
                        <a:t>ANGPT1; TEK; TNIP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맑은 고딕"/>
                        </a:rPr>
                        <a:t>Cell migra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ndothelial cell migra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O:004354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맑은 고딕"/>
                        </a:rPr>
                        <a:t>ANGPT1; ANGPT2; TEK; ID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98" name="TextBox 26"/>
          <p:cNvSpPr/>
          <p:nvPr/>
        </p:nvSpPr>
        <p:spPr>
          <a:xfrm>
            <a:off x="0" y="0"/>
            <a:ext cx="1893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굴림"/>
              </a:rPr>
              <a:t>Figure S3. Bae et al.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9" name="그룹 57"/>
          <p:cNvGrpSpPr/>
          <p:nvPr/>
        </p:nvGrpSpPr>
        <p:grpSpPr>
          <a:xfrm>
            <a:off x="1341360" y="2411280"/>
            <a:ext cx="4464000" cy="4029120"/>
            <a:chOff x="1341360" y="2411280"/>
            <a:chExt cx="4464000" cy="4029120"/>
          </a:xfrm>
        </p:grpSpPr>
        <p:sp>
          <p:nvSpPr>
            <p:cNvPr id="200" name="직선 연결선 2"/>
            <p:cNvSpPr/>
            <p:nvPr/>
          </p:nvSpPr>
          <p:spPr>
            <a:xfrm flipV="1">
              <a:off x="1844280" y="3274560"/>
              <a:ext cx="3457800" cy="20890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01" name="직선 연결선 3"/>
            <p:cNvSpPr/>
            <p:nvPr/>
          </p:nvSpPr>
          <p:spPr>
            <a:xfrm flipV="1">
              <a:off x="3573360" y="2482200"/>
              <a:ext cx="0" cy="35290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02" name="직선 연결선 4"/>
            <p:cNvSpPr/>
            <p:nvPr/>
          </p:nvSpPr>
          <p:spPr>
            <a:xfrm>
              <a:off x="1773000" y="3347640"/>
              <a:ext cx="3600360" cy="20160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grpSp>
          <p:nvGrpSpPr>
            <p:cNvPr id="203" name="그룹 43"/>
            <p:cNvGrpSpPr/>
            <p:nvPr/>
          </p:nvGrpSpPr>
          <p:grpSpPr>
            <a:xfrm>
              <a:off x="4509360" y="4787640"/>
              <a:ext cx="1224000" cy="936000"/>
              <a:chOff x="4509360" y="4787640"/>
              <a:chExt cx="1224000" cy="936000"/>
            </a:xfrm>
          </p:grpSpPr>
          <p:sp>
            <p:nvSpPr>
              <p:cNvPr id="204" name="타원 30"/>
              <p:cNvSpPr/>
              <p:nvPr/>
            </p:nvSpPr>
            <p:spPr>
              <a:xfrm>
                <a:off x="4509720" y="4787640"/>
                <a:ext cx="1223640" cy="936000"/>
              </a:xfrm>
              <a:prstGeom prst="ellipse">
                <a:avLst/>
              </a:prstGeom>
              <a:solidFill>
                <a:srgbClr val="f2dcdb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05" name="TextBox 54"/>
              <p:cNvSpPr/>
              <p:nvPr/>
            </p:nvSpPr>
            <p:spPr>
              <a:xfrm>
                <a:off x="4509360" y="4934880"/>
                <a:ext cx="1223640" cy="641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Calibri"/>
                    <a:ea typeface="맑은 고딕"/>
                  </a:rPr>
                  <a:t>Environmental Information Processing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206" name="그룹 56"/>
            <p:cNvGrpSpPr/>
            <p:nvPr/>
          </p:nvGrpSpPr>
          <p:grpSpPr>
            <a:xfrm>
              <a:off x="2970360" y="2411280"/>
              <a:ext cx="1224000" cy="936000"/>
              <a:chOff x="2970360" y="2411280"/>
              <a:chExt cx="1224000" cy="936000"/>
            </a:xfrm>
          </p:grpSpPr>
          <p:sp>
            <p:nvSpPr>
              <p:cNvPr id="207" name="타원 28"/>
              <p:cNvSpPr/>
              <p:nvPr/>
            </p:nvSpPr>
            <p:spPr>
              <a:xfrm>
                <a:off x="2970360" y="2411280"/>
                <a:ext cx="1224000" cy="936000"/>
              </a:xfrm>
              <a:prstGeom prst="ellipse">
                <a:avLst/>
              </a:prstGeom>
              <a:solidFill>
                <a:srgbClr val="ddd9c3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08" name="TextBox 52"/>
              <p:cNvSpPr/>
              <p:nvPr/>
            </p:nvSpPr>
            <p:spPr>
              <a:xfrm>
                <a:off x="2970360" y="2740680"/>
                <a:ext cx="1224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Calibri"/>
                    <a:ea typeface="맑은 고딕"/>
                  </a:rPr>
                  <a:t>Metabolism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pic>
          <p:nvPicPr>
            <p:cNvPr id="209" name="그룹 57" descr=""/>
            <p:cNvPicPr/>
            <p:nvPr/>
          </p:nvPicPr>
          <p:blipFill>
            <a:blip r:embed="rId1"/>
            <a:stretch/>
          </p:blipFill>
          <p:spPr>
            <a:xfrm>
              <a:off x="2785680" y="3565800"/>
              <a:ext cx="1596960" cy="15969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210" name="그룹 45"/>
            <p:cNvGrpSpPr/>
            <p:nvPr/>
          </p:nvGrpSpPr>
          <p:grpSpPr>
            <a:xfrm>
              <a:off x="4581360" y="3059280"/>
              <a:ext cx="1224000" cy="936000"/>
              <a:chOff x="4581360" y="3059280"/>
              <a:chExt cx="1224000" cy="936000"/>
            </a:xfrm>
          </p:grpSpPr>
          <p:sp>
            <p:nvSpPr>
              <p:cNvPr id="211" name="타원 24"/>
              <p:cNvSpPr/>
              <p:nvPr/>
            </p:nvSpPr>
            <p:spPr>
              <a:xfrm>
                <a:off x="4581360" y="3059280"/>
                <a:ext cx="1224000" cy="936000"/>
              </a:xfrm>
              <a:prstGeom prst="ellipse">
                <a:avLst/>
              </a:prstGeom>
              <a:solidFill>
                <a:srgbClr val="c6d9f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12" name="TextBox 48"/>
              <p:cNvSpPr/>
              <p:nvPr/>
            </p:nvSpPr>
            <p:spPr>
              <a:xfrm>
                <a:off x="4581360" y="3206520"/>
                <a:ext cx="1224000" cy="641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Calibri"/>
                    <a:ea typeface="맑은 고딕"/>
                  </a:rPr>
                  <a:t>Genetic Information Processing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213" name="그룹 46"/>
            <p:cNvGrpSpPr/>
            <p:nvPr/>
          </p:nvGrpSpPr>
          <p:grpSpPr>
            <a:xfrm>
              <a:off x="2970360" y="5363640"/>
              <a:ext cx="1224000" cy="936000"/>
              <a:chOff x="2970360" y="5363640"/>
              <a:chExt cx="1224000" cy="936000"/>
            </a:xfrm>
          </p:grpSpPr>
          <p:sp>
            <p:nvSpPr>
              <p:cNvPr id="214" name="타원 22"/>
              <p:cNvSpPr/>
              <p:nvPr/>
            </p:nvSpPr>
            <p:spPr>
              <a:xfrm>
                <a:off x="2970360" y="5363640"/>
                <a:ext cx="1224000" cy="936000"/>
              </a:xfrm>
              <a:prstGeom prst="ellipse">
                <a:avLst/>
              </a:prstGeom>
              <a:solidFill>
                <a:srgbClr val="d7e4b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15" name="TextBox 46"/>
              <p:cNvSpPr/>
              <p:nvPr/>
            </p:nvSpPr>
            <p:spPr>
              <a:xfrm>
                <a:off x="2970360" y="5601960"/>
                <a:ext cx="122400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Calibri"/>
                    <a:ea typeface="맑은 고딕"/>
                  </a:rPr>
                  <a:t>Cellular Processes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216" name="그룹 47"/>
            <p:cNvGrpSpPr/>
            <p:nvPr/>
          </p:nvGrpSpPr>
          <p:grpSpPr>
            <a:xfrm>
              <a:off x="1341360" y="3131280"/>
              <a:ext cx="1224000" cy="936000"/>
              <a:chOff x="1341360" y="3131280"/>
              <a:chExt cx="1224000" cy="936000"/>
            </a:xfrm>
          </p:grpSpPr>
          <p:sp>
            <p:nvSpPr>
              <p:cNvPr id="217" name="타원 20"/>
              <p:cNvSpPr/>
              <p:nvPr/>
            </p:nvSpPr>
            <p:spPr>
              <a:xfrm>
                <a:off x="1341360" y="3131280"/>
                <a:ext cx="1224000" cy="936000"/>
              </a:xfrm>
              <a:prstGeom prst="ellipse">
                <a:avLst/>
              </a:prstGeom>
              <a:solidFill>
                <a:srgbClr val="c4bd97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18" name="TextBox 44"/>
              <p:cNvSpPr/>
              <p:nvPr/>
            </p:nvSpPr>
            <p:spPr>
              <a:xfrm>
                <a:off x="1341360" y="3460680"/>
                <a:ext cx="1224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Calibri"/>
                    <a:ea typeface="맑은 고딕"/>
                  </a:rPr>
                  <a:t>Human Diseases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219" name="그룹 48"/>
            <p:cNvGrpSpPr/>
            <p:nvPr/>
          </p:nvGrpSpPr>
          <p:grpSpPr>
            <a:xfrm>
              <a:off x="1341360" y="4787640"/>
              <a:ext cx="1224000" cy="936000"/>
              <a:chOff x="1341360" y="4787640"/>
              <a:chExt cx="1224000" cy="936000"/>
            </a:xfrm>
          </p:grpSpPr>
          <p:sp>
            <p:nvSpPr>
              <p:cNvPr id="220" name="타원 18"/>
              <p:cNvSpPr/>
              <p:nvPr/>
            </p:nvSpPr>
            <p:spPr>
              <a:xfrm>
                <a:off x="1341360" y="4787640"/>
                <a:ext cx="1224000" cy="936000"/>
              </a:xfrm>
              <a:prstGeom prst="ellipse">
                <a:avLst/>
              </a:prstGeom>
              <a:solidFill>
                <a:srgbClr val="ccc1d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21" name="TextBox 42"/>
              <p:cNvSpPr/>
              <p:nvPr/>
            </p:nvSpPr>
            <p:spPr>
              <a:xfrm>
                <a:off x="1341360" y="5025960"/>
                <a:ext cx="122400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Calibri"/>
                    <a:ea typeface="맑은 고딕"/>
                  </a:rPr>
                  <a:t>Organismal Systems</a:t>
                </a:r>
                <a:endParaRPr b="0" lang="en-US" sz="12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sp>
          <p:nvSpPr>
            <p:cNvPr id="222" name="모서리가 둥근 직사각형 12"/>
            <p:cNvSpPr/>
            <p:nvPr/>
          </p:nvSpPr>
          <p:spPr>
            <a:xfrm>
              <a:off x="4694040" y="5559480"/>
              <a:ext cx="863640" cy="880920"/>
            </a:xfrm>
            <a:custGeom>
              <a:avLst/>
              <a:gdLst>
                <a:gd name="textAreaLeft" fmla="*/ 42120 w 863640"/>
                <a:gd name="textAreaRight" fmla="*/ 821520 w 863640"/>
                <a:gd name="textAreaTop" fmla="*/ 42120 h 880920"/>
                <a:gd name="textAreaBottom" fmla="*/ 838800 h 880920"/>
              </a:gdLst>
              <a:ahLst/>
              <a:rect l="textAreaLeft" t="textAreaTop" r="textAreaRight" b="textAreaBottom"/>
              <a:pathLst>
                <a:path w="21600" h="22032">
                  <a:moveTo>
                    <a:pt x="3600" y="0"/>
                  </a:moveTo>
                  <a:arcTo wR="3600" hR="3600" stAng="16200000" swAng="-5400000"/>
                  <a:lnTo>
                    <a:pt x="0" y="18432"/>
                  </a:lnTo>
                  <a:arcTo wR="3600" hR="3600" stAng="10800000" swAng="-5400000"/>
                  <a:lnTo>
                    <a:pt x="18000" y="22032"/>
                  </a:lnTo>
                  <a:arcTo wR="3600" hR="3600" stAng="5400000" swAng="-5400000"/>
                  <a:lnTo>
                    <a:pt x="21600" y="3600"/>
                  </a:lnTo>
                  <a:arcTo wR="3600" hR="3600" stAng="0" swAng="-5400000"/>
                  <a:close/>
                </a:path>
              </a:pathLst>
            </a:cu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ffffff"/>
                  </a:solidFill>
                  <a:latin typeface="Calibri"/>
                  <a:ea typeface="맑은 고딕"/>
                </a:rPr>
                <a:t>ANGPT1</a:t>
              </a:r>
              <a:endParaRPr b="0" lang="en-US" sz="1100" spc="-1" strike="noStrike">
                <a:solidFill>
                  <a:srgbClr val="000000"/>
                </a:solidFill>
                <a:latin typeface="굴림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ffffff"/>
                  </a:solidFill>
                  <a:latin typeface="Calibri"/>
                  <a:ea typeface="맑은 고딕"/>
                </a:rPr>
                <a:t>CTGF</a:t>
              </a:r>
              <a:endParaRPr b="0" lang="en-US" sz="1100" spc="-1" strike="noStrike">
                <a:solidFill>
                  <a:srgbClr val="000000"/>
                </a:solidFill>
                <a:latin typeface="굴림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ffffff"/>
                  </a:solidFill>
                  <a:latin typeface="Calibri"/>
                  <a:ea typeface="맑은 고딕"/>
                </a:rPr>
                <a:t>IFI16</a:t>
              </a:r>
              <a:endParaRPr b="0" lang="en-US" sz="1100" spc="-1" strike="noStrike">
                <a:solidFill>
                  <a:srgbClr val="000000"/>
                </a:solidFill>
                <a:latin typeface="굴림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ffffff"/>
                  </a:solidFill>
                  <a:latin typeface="Calibri"/>
                  <a:ea typeface="맑은 고딕"/>
                </a:rPr>
                <a:t>RASAL1</a:t>
              </a:r>
              <a:endParaRPr b="0" lang="en-US" sz="1100" spc="-1" strike="noStrike">
                <a:solidFill>
                  <a:srgbClr val="000000"/>
                </a:solidFill>
                <a:latin typeface="굴림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ffffff"/>
                  </a:solidFill>
                  <a:latin typeface="Calibri"/>
                  <a:ea typeface="맑은 고딕"/>
                </a:rPr>
                <a:t>SP1</a:t>
              </a:r>
              <a:endParaRPr b="0" lang="en-US" sz="11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23" name="모서리가 둥근 직사각형 13"/>
            <p:cNvSpPr/>
            <p:nvPr/>
          </p:nvSpPr>
          <p:spPr>
            <a:xfrm>
              <a:off x="4761000" y="3848040"/>
              <a:ext cx="865080" cy="360360"/>
            </a:xfrm>
            <a:prstGeom prst="roundRect">
              <a:avLst>
                <a:gd name="adj" fmla="val 16667"/>
              </a:avLst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ffffff"/>
                  </a:solidFill>
                  <a:latin typeface="Calibri"/>
                  <a:ea typeface="맑은 고딕"/>
                </a:rPr>
                <a:t>LMAN1</a:t>
              </a:r>
              <a:endParaRPr b="0" lang="en-US" sz="1100" spc="-1" strike="noStrike">
                <a:solidFill>
                  <a:srgbClr val="000000"/>
                </a:solidFill>
                <a:latin typeface="굴림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ffffff"/>
                  </a:solidFill>
                  <a:latin typeface="Calibri"/>
                  <a:ea typeface="맑은 고딕"/>
                </a:rPr>
                <a:t>ZNF175</a:t>
              </a:r>
              <a:endParaRPr b="0" lang="en-US" sz="11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24" name="모서리가 둥근 직사각형 14"/>
            <p:cNvSpPr/>
            <p:nvPr/>
          </p:nvSpPr>
          <p:spPr>
            <a:xfrm>
              <a:off x="3151080" y="3058920"/>
              <a:ext cx="863640" cy="360360"/>
            </a:xfrm>
            <a:prstGeom prst="roundRect">
              <a:avLst>
                <a:gd name="adj" fmla="val 16667"/>
              </a:avLst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ffffff"/>
                  </a:solidFill>
                  <a:latin typeface="Calibri"/>
                  <a:ea typeface="맑은 고딕"/>
                </a:rPr>
                <a:t>ATP5A1</a:t>
              </a:r>
              <a:endParaRPr b="0" lang="en-US" sz="1100" spc="-1" strike="noStrike">
                <a:solidFill>
                  <a:srgbClr val="000000"/>
                </a:solidFill>
                <a:latin typeface="굴림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ffffff"/>
                  </a:solidFill>
                  <a:latin typeface="Calibri"/>
                  <a:ea typeface="맑은 고딕"/>
                </a:rPr>
                <a:t>LBR</a:t>
              </a:r>
              <a:endParaRPr b="0" lang="en-US" sz="11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25" name="모서리가 둥근 직사각형 15"/>
            <p:cNvSpPr/>
            <p:nvPr/>
          </p:nvSpPr>
          <p:spPr>
            <a:xfrm>
              <a:off x="1557000" y="3706560"/>
              <a:ext cx="863640" cy="714240"/>
            </a:xfrm>
            <a:prstGeom prst="roundRect">
              <a:avLst>
                <a:gd name="adj" fmla="val 16667"/>
              </a:avLst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ffffff"/>
                  </a:solidFill>
                  <a:latin typeface="Calibri"/>
                  <a:ea typeface="맑은 고딕"/>
                </a:rPr>
                <a:t>ANGPT1</a:t>
              </a:r>
              <a:endParaRPr b="0" lang="en-US" sz="1100" spc="-1" strike="noStrike">
                <a:solidFill>
                  <a:srgbClr val="000000"/>
                </a:solidFill>
                <a:latin typeface="굴림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ffffff"/>
                  </a:solidFill>
                  <a:latin typeface="Calibri"/>
                  <a:ea typeface="맑은 고딕"/>
                </a:rPr>
                <a:t>ATP5A1</a:t>
              </a:r>
              <a:endParaRPr b="0" lang="en-US" sz="1100" spc="-1" strike="noStrike">
                <a:solidFill>
                  <a:srgbClr val="000000"/>
                </a:solidFill>
                <a:latin typeface="굴림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ffffff"/>
                  </a:solidFill>
                  <a:latin typeface="Calibri"/>
                  <a:ea typeface="맑은 고딕"/>
                </a:rPr>
                <a:t>SP1</a:t>
              </a:r>
              <a:endParaRPr b="0" lang="en-US" sz="1100" spc="-1" strike="noStrike">
                <a:solidFill>
                  <a:srgbClr val="000000"/>
                </a:solidFill>
                <a:latin typeface="굴림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ffffff"/>
                  </a:solidFill>
                  <a:latin typeface="Calibri"/>
                  <a:ea typeface="맑은 고딕"/>
                </a:rPr>
                <a:t>PLEKHM2</a:t>
              </a:r>
              <a:endParaRPr b="0" lang="en-US" sz="11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26" name="모서리가 둥근 직사각형 16"/>
            <p:cNvSpPr/>
            <p:nvPr/>
          </p:nvSpPr>
          <p:spPr>
            <a:xfrm>
              <a:off x="1549080" y="5495760"/>
              <a:ext cx="863640" cy="503280"/>
            </a:xfrm>
            <a:prstGeom prst="roundRect">
              <a:avLst>
                <a:gd name="adj" fmla="val 16667"/>
              </a:avLst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ffffff"/>
                  </a:solidFill>
                  <a:latin typeface="Calibri"/>
                  <a:ea typeface="맑은 고딕"/>
                </a:rPr>
                <a:t>IFI16</a:t>
              </a:r>
              <a:endParaRPr b="0" lang="en-US" sz="1100" spc="-1" strike="noStrike">
                <a:solidFill>
                  <a:srgbClr val="000000"/>
                </a:solidFill>
                <a:latin typeface="굴림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ffffff"/>
                  </a:solidFill>
                  <a:latin typeface="Calibri"/>
                  <a:ea typeface="맑은 고딕"/>
                </a:rPr>
                <a:t>MCOLN1</a:t>
              </a:r>
              <a:endParaRPr b="0" lang="en-US" sz="1100" spc="-1" strike="noStrike">
                <a:solidFill>
                  <a:srgbClr val="000000"/>
                </a:solidFill>
                <a:latin typeface="굴림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ffffff"/>
                  </a:solidFill>
                  <a:latin typeface="Calibri"/>
                  <a:ea typeface="맑은 고딕"/>
                </a:rPr>
                <a:t>SP1</a:t>
              </a:r>
              <a:endParaRPr b="0" lang="en-US" sz="11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27" name="모서리가 둥근 직사각형 16"/>
            <p:cNvSpPr/>
            <p:nvPr/>
          </p:nvSpPr>
          <p:spPr>
            <a:xfrm>
              <a:off x="3151080" y="6064200"/>
              <a:ext cx="863640" cy="360360"/>
            </a:xfrm>
            <a:prstGeom prst="roundRect">
              <a:avLst>
                <a:gd name="adj" fmla="val 16667"/>
              </a:avLst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ffffff"/>
                  </a:solidFill>
                  <a:latin typeface="Calibri"/>
                  <a:ea typeface="맑은 고딕"/>
                </a:rPr>
                <a:t>MCOLN1</a:t>
              </a:r>
              <a:endParaRPr b="0" lang="en-US" sz="1100" spc="-1" strike="noStrike">
                <a:solidFill>
                  <a:srgbClr val="000000"/>
                </a:solidFill>
                <a:latin typeface="굴림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ffffff"/>
                  </a:solidFill>
                  <a:latin typeface="Calibri"/>
                  <a:ea typeface="맑은 고딕"/>
                </a:rPr>
                <a:t>IFI16</a:t>
              </a:r>
              <a:endParaRPr b="0" lang="en-US" sz="11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sp>
        <p:nvSpPr>
          <p:cNvPr id="228" name="TextBox 32"/>
          <p:cNvSpPr/>
          <p:nvPr/>
        </p:nvSpPr>
        <p:spPr>
          <a:xfrm>
            <a:off x="0" y="539640"/>
            <a:ext cx="4392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맑은 고딕"/>
              </a:rPr>
              <a:t>KEGG Orthology (KO)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29" name="TextBox 26"/>
          <p:cNvSpPr/>
          <p:nvPr/>
        </p:nvSpPr>
        <p:spPr>
          <a:xfrm>
            <a:off x="0" y="0"/>
            <a:ext cx="1893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굴림"/>
              </a:rPr>
              <a:t>Figure S4. Bae et al.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7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28T05:13:48Z</dcterms:created>
  <dc:creator>user</dc:creator>
  <dc:description/>
  <dc:language>en-US</dc:language>
  <cp:lastModifiedBy>d</cp:lastModifiedBy>
  <cp:lastPrinted>2014-07-25T01:46:02Z</cp:lastPrinted>
  <dcterms:modified xsi:type="dcterms:W3CDTF">2014-12-09T05:03:20Z</dcterms:modified>
  <cp:revision>319</cp:revision>
  <dc:subject/>
  <dc:title>슬라이드 1</dc:title>
</cp:coreProperties>
</file>